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E0E0"/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0598" autoAdjust="0"/>
  </p:normalViewPr>
  <p:slideViewPr>
    <p:cSldViewPr>
      <p:cViewPr>
        <p:scale>
          <a:sx n="110" d="100"/>
          <a:sy n="110" d="100"/>
        </p:scale>
        <p:origin x="-18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B53EF-3AE7-484E-9BAC-564CAAF4E700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DA31B0-2556-4684-8750-BF1D8261D7A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99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96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676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778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988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290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435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86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3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154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692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6548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BB526-5326-432C-B1B9-8029C7855CE6}" type="datetimeFigureOut">
              <a:rPr lang="it-IT" smtClean="0"/>
              <a:pPr/>
              <a:t>10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535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0408959"/>
              </p:ext>
            </p:extLst>
          </p:nvPr>
        </p:nvGraphicFramePr>
        <p:xfrm>
          <a:off x="1713835" y="897687"/>
          <a:ext cx="5664200" cy="4416552"/>
        </p:xfrm>
        <a:graphic>
          <a:graphicData uri="http://schemas.openxmlformats.org/drawingml/2006/table">
            <a:tbl>
              <a:tblPr/>
              <a:tblGrid>
                <a:gridCol w="2679065"/>
                <a:gridCol w="2985135"/>
              </a:tblGrid>
              <a:tr h="17145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Primer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equence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CAM-1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AGCCAGCAGATTACAATGC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CAM-1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GGCTGGGAACAATATCCAC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CGR3a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CAAAAGCCACACTCAAAGAC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FCGR3a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CCCAGGTGGAAAGAATGATG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DNAM-1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GCACATTGTTTCGGAACCTGGAA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DNAM-1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TGCCATGGACCAAGTTGCAGTA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GK2D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CTCGACACAGCTGGGAGATC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GK2D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AGGCCAGCAAACTCTCTTC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Kp46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CGGGACTCCAGAAAGACCAT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Kp46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AGGCCCATCCGAAGGA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Kp44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TACGAGAAGAAAGGCTGGTG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Kp44-REV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AATCGAGAGGTCCAAGCCAT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Kp30-FWD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GTGGAGAAAGAACATCCTCA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NKp30-REV</a:t>
                      </a:r>
                      <a:endParaRPr lang="it-IT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AAGCTGACAGCATAGAATCCAG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KLRB1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ACAGACTCAGGCCCAGAAAGT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KLRB1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it-IT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CCCAGCACAGCTAAGTTTCAGG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GFB1-FWD</a:t>
                      </a:r>
                      <a:endParaRPr lang="it-IT" sz="120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TGGGGGCTGTATTTAAGGA</a:t>
                      </a:r>
                      <a:endParaRPr lang="it-IT" sz="120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TGFB1-</a:t>
                      </a:r>
                      <a:r>
                        <a:rPr lang="it-IT" sz="12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REV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AGGCAGAGAGGGAGAGAGA </a:t>
                      </a:r>
                      <a:endParaRPr lang="it-IT" sz="1200" kern="12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USB-FWD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GCCAGTTCCTCATCAATGG</a:t>
                      </a:r>
                      <a:endParaRPr lang="it-IT" sz="12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GUSB-REV</a:t>
                      </a:r>
                      <a:endParaRPr lang="it-IT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GTAGTGGCTGGTACGGAAA</a:t>
                      </a:r>
                      <a:endParaRPr lang="it-IT" sz="12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619672" y="631721"/>
            <a:ext cx="51845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able </a:t>
            </a:r>
            <a:r>
              <a:rPr lang="en-US" sz="1200" b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1: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imer sequences for SYBR Green RT-qPCR </a:t>
            </a:r>
            <a:endParaRPr kumimoji="0" lang="en-US" sz="12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92</TotalTime>
  <Words>52</Words>
  <Application>Microsoft Office PowerPoint</Application>
  <PresentationFormat>Presentazione su schermo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ALA</dc:creator>
  <cp:lastModifiedBy>Genomica Funzionale</cp:lastModifiedBy>
  <cp:revision>615</cp:revision>
  <dcterms:created xsi:type="dcterms:W3CDTF">2016-04-07T07:01:43Z</dcterms:created>
  <dcterms:modified xsi:type="dcterms:W3CDTF">2018-10-10T10:12:49Z</dcterms:modified>
</cp:coreProperties>
</file>